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3" r:id="rId2"/>
  </p:sldIdLst>
  <p:sldSz cx="6675438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1FF20"/>
    <a:srgbClr val="912FE7"/>
    <a:srgbClr val="FF7E79"/>
    <a:srgbClr val="009193"/>
    <a:srgbClr val="FF222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27D3937-3DCD-4963-B91D-186384807C73}" v="13" dt="2023-07-29T00:11:31.98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69"/>
    <p:restoredTop sz="93878"/>
  </p:normalViewPr>
  <p:slideViewPr>
    <p:cSldViewPr>
      <p:cViewPr varScale="1">
        <p:scale>
          <a:sx n="79" d="100"/>
          <a:sy n="79" d="100"/>
        </p:scale>
        <p:origin x="401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38100" cy="381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211391-BB7C-E947-AA9E-BB08191871A3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5063" y="1143000"/>
            <a:ext cx="2047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ECE02E-D798-A544-842D-50672B18D3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2879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E664CC-816F-134A-B2E0-1A0A6B40452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3270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00658" y="1646133"/>
            <a:ext cx="5674122" cy="3501813"/>
          </a:xfrm>
        </p:spPr>
        <p:txBody>
          <a:bodyPr anchor="b"/>
          <a:lstStyle>
            <a:lvl1pPr algn="ctr">
              <a:defRPr sz="43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4430" y="5282989"/>
            <a:ext cx="5006579" cy="2428451"/>
          </a:xfrm>
        </p:spPr>
        <p:txBody>
          <a:bodyPr/>
          <a:lstStyle>
            <a:lvl1pPr marL="0" indent="0" algn="ctr">
              <a:buNone/>
              <a:defRPr sz="1752"/>
            </a:lvl1pPr>
            <a:lvl2pPr marL="333756" indent="0" algn="ctr">
              <a:buNone/>
              <a:defRPr sz="1460"/>
            </a:lvl2pPr>
            <a:lvl3pPr marL="667512" indent="0" algn="ctr">
              <a:buNone/>
              <a:defRPr sz="1314"/>
            </a:lvl3pPr>
            <a:lvl4pPr marL="1001268" indent="0" algn="ctr">
              <a:buNone/>
              <a:defRPr sz="1168"/>
            </a:lvl4pPr>
            <a:lvl5pPr marL="1335024" indent="0" algn="ctr">
              <a:buNone/>
              <a:defRPr sz="1168"/>
            </a:lvl5pPr>
            <a:lvl6pPr marL="1668780" indent="0" algn="ctr">
              <a:buNone/>
              <a:defRPr sz="1168"/>
            </a:lvl6pPr>
            <a:lvl7pPr marL="2002536" indent="0" algn="ctr">
              <a:buNone/>
              <a:defRPr sz="1168"/>
            </a:lvl7pPr>
            <a:lvl8pPr marL="2336292" indent="0" algn="ctr">
              <a:buNone/>
              <a:defRPr sz="1168"/>
            </a:lvl8pPr>
            <a:lvl9pPr marL="2670048" indent="0" algn="ctr">
              <a:buNone/>
              <a:defRPr sz="116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35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307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77111" y="535517"/>
            <a:ext cx="1439391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8937" y="535517"/>
            <a:ext cx="4234731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85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748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5460" y="2507618"/>
            <a:ext cx="5757565" cy="4184014"/>
          </a:xfrm>
        </p:spPr>
        <p:txBody>
          <a:bodyPr anchor="b"/>
          <a:lstStyle>
            <a:lvl1pPr>
              <a:defRPr sz="43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5460" y="6731215"/>
            <a:ext cx="5757565" cy="2200274"/>
          </a:xfrm>
        </p:spPr>
        <p:txBody>
          <a:bodyPr/>
          <a:lstStyle>
            <a:lvl1pPr marL="0" indent="0">
              <a:buNone/>
              <a:defRPr sz="1752">
                <a:solidFill>
                  <a:schemeClr val="tx1"/>
                </a:solidFill>
              </a:defRPr>
            </a:lvl1pPr>
            <a:lvl2pPr marL="333756" indent="0">
              <a:buNone/>
              <a:defRPr sz="1460">
                <a:solidFill>
                  <a:schemeClr val="tx1">
                    <a:tint val="75000"/>
                  </a:schemeClr>
                </a:solidFill>
              </a:defRPr>
            </a:lvl2pPr>
            <a:lvl3pPr marL="667512" indent="0">
              <a:buNone/>
              <a:defRPr sz="1314">
                <a:solidFill>
                  <a:schemeClr val="tx1">
                    <a:tint val="75000"/>
                  </a:schemeClr>
                </a:solidFill>
              </a:defRPr>
            </a:lvl3pPr>
            <a:lvl4pPr marL="1001268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4pPr>
            <a:lvl5pPr marL="1335024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5pPr>
            <a:lvl6pPr marL="1668780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6pPr>
            <a:lvl7pPr marL="2002536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7pPr>
            <a:lvl8pPr marL="2336292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8pPr>
            <a:lvl9pPr marL="2670048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980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8936" y="2677584"/>
            <a:ext cx="2837061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79441" y="2677584"/>
            <a:ext cx="2837061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28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535519"/>
            <a:ext cx="575756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9806" y="2465706"/>
            <a:ext cx="2824023" cy="1208404"/>
          </a:xfrm>
        </p:spPr>
        <p:txBody>
          <a:bodyPr anchor="b"/>
          <a:lstStyle>
            <a:lvl1pPr marL="0" indent="0">
              <a:buNone/>
              <a:defRPr sz="1752" b="1"/>
            </a:lvl1pPr>
            <a:lvl2pPr marL="333756" indent="0">
              <a:buNone/>
              <a:defRPr sz="1460" b="1"/>
            </a:lvl2pPr>
            <a:lvl3pPr marL="667512" indent="0">
              <a:buNone/>
              <a:defRPr sz="1314" b="1"/>
            </a:lvl3pPr>
            <a:lvl4pPr marL="1001268" indent="0">
              <a:buNone/>
              <a:defRPr sz="1168" b="1"/>
            </a:lvl4pPr>
            <a:lvl5pPr marL="1335024" indent="0">
              <a:buNone/>
              <a:defRPr sz="1168" b="1"/>
            </a:lvl5pPr>
            <a:lvl6pPr marL="1668780" indent="0">
              <a:buNone/>
              <a:defRPr sz="1168" b="1"/>
            </a:lvl6pPr>
            <a:lvl7pPr marL="2002536" indent="0">
              <a:buNone/>
              <a:defRPr sz="1168" b="1"/>
            </a:lvl7pPr>
            <a:lvl8pPr marL="2336292" indent="0">
              <a:buNone/>
              <a:defRPr sz="1168" b="1"/>
            </a:lvl8pPr>
            <a:lvl9pPr marL="2670048" indent="0">
              <a:buNone/>
              <a:defRPr sz="116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9806" y="3674110"/>
            <a:ext cx="282402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79441" y="2465706"/>
            <a:ext cx="2837931" cy="1208404"/>
          </a:xfrm>
        </p:spPr>
        <p:txBody>
          <a:bodyPr anchor="b"/>
          <a:lstStyle>
            <a:lvl1pPr marL="0" indent="0">
              <a:buNone/>
              <a:defRPr sz="1752" b="1"/>
            </a:lvl1pPr>
            <a:lvl2pPr marL="333756" indent="0">
              <a:buNone/>
              <a:defRPr sz="1460" b="1"/>
            </a:lvl2pPr>
            <a:lvl3pPr marL="667512" indent="0">
              <a:buNone/>
              <a:defRPr sz="1314" b="1"/>
            </a:lvl3pPr>
            <a:lvl4pPr marL="1001268" indent="0">
              <a:buNone/>
              <a:defRPr sz="1168" b="1"/>
            </a:lvl4pPr>
            <a:lvl5pPr marL="1335024" indent="0">
              <a:buNone/>
              <a:defRPr sz="1168" b="1"/>
            </a:lvl5pPr>
            <a:lvl6pPr marL="1668780" indent="0">
              <a:buNone/>
              <a:defRPr sz="1168" b="1"/>
            </a:lvl6pPr>
            <a:lvl7pPr marL="2002536" indent="0">
              <a:buNone/>
              <a:defRPr sz="1168" b="1"/>
            </a:lvl7pPr>
            <a:lvl8pPr marL="2336292" indent="0">
              <a:buNone/>
              <a:defRPr sz="1168" b="1"/>
            </a:lvl8pPr>
            <a:lvl9pPr marL="2670048" indent="0">
              <a:buNone/>
              <a:defRPr sz="116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79441" y="3674110"/>
            <a:ext cx="2837931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08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023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092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670560"/>
            <a:ext cx="2153003" cy="2346960"/>
          </a:xfrm>
        </p:spPr>
        <p:txBody>
          <a:bodyPr anchor="b"/>
          <a:lstStyle>
            <a:lvl1pPr>
              <a:defRPr sz="23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37931" y="1448226"/>
            <a:ext cx="3379440" cy="7147983"/>
          </a:xfrm>
        </p:spPr>
        <p:txBody>
          <a:bodyPr/>
          <a:lstStyle>
            <a:lvl1pPr>
              <a:defRPr sz="2336"/>
            </a:lvl1pPr>
            <a:lvl2pPr>
              <a:defRPr sz="2044"/>
            </a:lvl2pPr>
            <a:lvl3pPr>
              <a:defRPr sz="1752"/>
            </a:lvl3pPr>
            <a:lvl4pPr>
              <a:defRPr sz="1460"/>
            </a:lvl4pPr>
            <a:lvl5pPr>
              <a:defRPr sz="1460"/>
            </a:lvl5pPr>
            <a:lvl6pPr>
              <a:defRPr sz="1460"/>
            </a:lvl6pPr>
            <a:lvl7pPr>
              <a:defRPr sz="1460"/>
            </a:lvl7pPr>
            <a:lvl8pPr>
              <a:defRPr sz="1460"/>
            </a:lvl8pPr>
            <a:lvl9pPr>
              <a:defRPr sz="14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9806" y="3017520"/>
            <a:ext cx="2153003" cy="5590329"/>
          </a:xfrm>
        </p:spPr>
        <p:txBody>
          <a:bodyPr/>
          <a:lstStyle>
            <a:lvl1pPr marL="0" indent="0">
              <a:buNone/>
              <a:defRPr sz="1168"/>
            </a:lvl1pPr>
            <a:lvl2pPr marL="333756" indent="0">
              <a:buNone/>
              <a:defRPr sz="1022"/>
            </a:lvl2pPr>
            <a:lvl3pPr marL="667512" indent="0">
              <a:buNone/>
              <a:defRPr sz="876"/>
            </a:lvl3pPr>
            <a:lvl4pPr marL="1001268" indent="0">
              <a:buNone/>
              <a:defRPr sz="730"/>
            </a:lvl4pPr>
            <a:lvl5pPr marL="1335024" indent="0">
              <a:buNone/>
              <a:defRPr sz="730"/>
            </a:lvl5pPr>
            <a:lvl6pPr marL="1668780" indent="0">
              <a:buNone/>
              <a:defRPr sz="730"/>
            </a:lvl6pPr>
            <a:lvl7pPr marL="2002536" indent="0">
              <a:buNone/>
              <a:defRPr sz="730"/>
            </a:lvl7pPr>
            <a:lvl8pPr marL="2336292" indent="0">
              <a:buNone/>
              <a:defRPr sz="730"/>
            </a:lvl8pPr>
            <a:lvl9pPr marL="2670048" indent="0">
              <a:buNone/>
              <a:defRPr sz="7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699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670560"/>
            <a:ext cx="2153003" cy="2346960"/>
          </a:xfrm>
        </p:spPr>
        <p:txBody>
          <a:bodyPr anchor="b"/>
          <a:lstStyle>
            <a:lvl1pPr>
              <a:defRPr sz="23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37931" y="1448226"/>
            <a:ext cx="3379440" cy="7147983"/>
          </a:xfrm>
        </p:spPr>
        <p:txBody>
          <a:bodyPr anchor="t"/>
          <a:lstStyle>
            <a:lvl1pPr marL="0" indent="0">
              <a:buNone/>
              <a:defRPr sz="2336"/>
            </a:lvl1pPr>
            <a:lvl2pPr marL="333756" indent="0">
              <a:buNone/>
              <a:defRPr sz="2044"/>
            </a:lvl2pPr>
            <a:lvl3pPr marL="667512" indent="0">
              <a:buNone/>
              <a:defRPr sz="1752"/>
            </a:lvl3pPr>
            <a:lvl4pPr marL="1001268" indent="0">
              <a:buNone/>
              <a:defRPr sz="1460"/>
            </a:lvl4pPr>
            <a:lvl5pPr marL="1335024" indent="0">
              <a:buNone/>
              <a:defRPr sz="1460"/>
            </a:lvl5pPr>
            <a:lvl6pPr marL="1668780" indent="0">
              <a:buNone/>
              <a:defRPr sz="1460"/>
            </a:lvl6pPr>
            <a:lvl7pPr marL="2002536" indent="0">
              <a:buNone/>
              <a:defRPr sz="1460"/>
            </a:lvl7pPr>
            <a:lvl8pPr marL="2336292" indent="0">
              <a:buNone/>
              <a:defRPr sz="1460"/>
            </a:lvl8pPr>
            <a:lvl9pPr marL="2670048" indent="0">
              <a:buNone/>
              <a:defRPr sz="14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9806" y="3017520"/>
            <a:ext cx="2153003" cy="5590329"/>
          </a:xfrm>
        </p:spPr>
        <p:txBody>
          <a:bodyPr/>
          <a:lstStyle>
            <a:lvl1pPr marL="0" indent="0">
              <a:buNone/>
              <a:defRPr sz="1168"/>
            </a:lvl1pPr>
            <a:lvl2pPr marL="333756" indent="0">
              <a:buNone/>
              <a:defRPr sz="1022"/>
            </a:lvl2pPr>
            <a:lvl3pPr marL="667512" indent="0">
              <a:buNone/>
              <a:defRPr sz="876"/>
            </a:lvl3pPr>
            <a:lvl4pPr marL="1001268" indent="0">
              <a:buNone/>
              <a:defRPr sz="730"/>
            </a:lvl4pPr>
            <a:lvl5pPr marL="1335024" indent="0">
              <a:buNone/>
              <a:defRPr sz="730"/>
            </a:lvl5pPr>
            <a:lvl6pPr marL="1668780" indent="0">
              <a:buNone/>
              <a:defRPr sz="730"/>
            </a:lvl6pPr>
            <a:lvl7pPr marL="2002536" indent="0">
              <a:buNone/>
              <a:defRPr sz="730"/>
            </a:lvl7pPr>
            <a:lvl8pPr marL="2336292" indent="0">
              <a:buNone/>
              <a:defRPr sz="730"/>
            </a:lvl8pPr>
            <a:lvl9pPr marL="2670048" indent="0">
              <a:buNone/>
              <a:defRPr sz="7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305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8937" y="535519"/>
            <a:ext cx="575756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8937" y="2677584"/>
            <a:ext cx="575756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8936" y="9322649"/>
            <a:ext cx="1501974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1239" y="9322649"/>
            <a:ext cx="22529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14528" y="9322649"/>
            <a:ext cx="1501974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989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67512" rtl="0" eaLnBrk="1" latinLnBrk="0" hangingPunct="1">
        <a:lnSpc>
          <a:spcPct val="90000"/>
        </a:lnSpc>
        <a:spcBef>
          <a:spcPct val="0"/>
        </a:spcBef>
        <a:buNone/>
        <a:defRPr sz="321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6878" indent="-166878" algn="l" defTabSz="667512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044" kern="1200">
          <a:solidFill>
            <a:schemeClr val="tx1"/>
          </a:solidFill>
          <a:latin typeface="+mn-lt"/>
          <a:ea typeface="+mn-ea"/>
          <a:cs typeface="+mn-cs"/>
        </a:defRPr>
      </a:lvl1pPr>
      <a:lvl2pPr marL="500634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752" kern="1200">
          <a:solidFill>
            <a:schemeClr val="tx1"/>
          </a:solidFill>
          <a:latin typeface="+mn-lt"/>
          <a:ea typeface="+mn-ea"/>
          <a:cs typeface="+mn-cs"/>
        </a:defRPr>
      </a:lvl2pPr>
      <a:lvl3pPr marL="834390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460" kern="1200">
          <a:solidFill>
            <a:schemeClr val="tx1"/>
          </a:solidFill>
          <a:latin typeface="+mn-lt"/>
          <a:ea typeface="+mn-ea"/>
          <a:cs typeface="+mn-cs"/>
        </a:defRPr>
      </a:lvl3pPr>
      <a:lvl4pPr marL="1168146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4pPr>
      <a:lvl5pPr marL="1501902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5pPr>
      <a:lvl6pPr marL="1835658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6pPr>
      <a:lvl7pPr marL="2169414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7pPr>
      <a:lvl8pPr marL="2503170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8pPr>
      <a:lvl9pPr marL="2836926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1pPr>
      <a:lvl2pPr marL="333756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2pPr>
      <a:lvl3pPr marL="667512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3pPr>
      <a:lvl4pPr marL="1001268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4pPr>
      <a:lvl5pPr marL="1335024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5pPr>
      <a:lvl6pPr marL="1668780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6pPr>
      <a:lvl7pPr marL="2002536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7pPr>
      <a:lvl8pPr marL="2336292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8pPr>
      <a:lvl9pPr marL="2670048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EEA06B3-4C63-60CB-54D6-27A0B1B6B4F4}"/>
              </a:ext>
            </a:extLst>
          </p:cNvPr>
          <p:cNvSpPr txBox="1"/>
          <p:nvPr/>
        </p:nvSpPr>
        <p:spPr>
          <a:xfrm>
            <a:off x="146575" y="197138"/>
            <a:ext cx="22159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12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431B8C2-7BC9-07F1-CDEE-F93C010FBE9A}"/>
              </a:ext>
            </a:extLst>
          </p:cNvPr>
          <p:cNvGrpSpPr/>
          <p:nvPr/>
        </p:nvGrpSpPr>
        <p:grpSpPr>
          <a:xfrm>
            <a:off x="899319" y="1447800"/>
            <a:ext cx="4423924" cy="1870248"/>
            <a:chOff x="915765" y="876300"/>
            <a:chExt cx="4423924" cy="1870248"/>
          </a:xfrm>
        </p:grpSpPr>
        <p:sp>
          <p:nvSpPr>
            <p:cNvPr id="388" name="TextBox 387">
              <a:extLst>
                <a:ext uri="{FF2B5EF4-FFF2-40B4-BE49-F238E27FC236}">
                  <a16:creationId xmlns:a16="http://schemas.microsoft.com/office/drawing/2014/main" id="{1F9D6FAB-2E12-03DD-C333-18F44FF1C267}"/>
                </a:ext>
              </a:extLst>
            </p:cNvPr>
            <p:cNvSpPr txBox="1"/>
            <p:nvPr/>
          </p:nvSpPr>
          <p:spPr>
            <a:xfrm flipH="1">
              <a:off x="3884301" y="876300"/>
              <a:ext cx="45333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414" name="Picture 413">
              <a:extLst>
                <a:ext uri="{FF2B5EF4-FFF2-40B4-BE49-F238E27FC236}">
                  <a16:creationId xmlns:a16="http://schemas.microsoft.com/office/drawing/2014/main" id="{821FDFF3-6F07-BA49-7FD3-E880D21C7E0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68630" y="1567013"/>
              <a:ext cx="635001" cy="237734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417" name="TextBox 416">
              <a:extLst>
                <a:ext uri="{FF2B5EF4-FFF2-40B4-BE49-F238E27FC236}">
                  <a16:creationId xmlns:a16="http://schemas.microsoft.com/office/drawing/2014/main" id="{2F19E3E3-3B3E-036F-FBA1-132D86DC7889}"/>
                </a:ext>
              </a:extLst>
            </p:cNvPr>
            <p:cNvSpPr txBox="1"/>
            <p:nvPr/>
          </p:nvSpPr>
          <p:spPr>
            <a:xfrm>
              <a:off x="915765" y="1559200"/>
              <a:ext cx="588623" cy="2700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IM17A</a:t>
              </a:r>
            </a:p>
          </p:txBody>
        </p:sp>
        <p:grpSp>
          <p:nvGrpSpPr>
            <p:cNvPr id="419" name="Group 418">
              <a:extLst>
                <a:ext uri="{FF2B5EF4-FFF2-40B4-BE49-F238E27FC236}">
                  <a16:creationId xmlns:a16="http://schemas.microsoft.com/office/drawing/2014/main" id="{68A45CEC-DF98-E3FB-4B28-F42E6E96E374}"/>
                </a:ext>
              </a:extLst>
            </p:cNvPr>
            <p:cNvGrpSpPr/>
            <p:nvPr/>
          </p:nvGrpSpPr>
          <p:grpSpPr>
            <a:xfrm>
              <a:off x="1100769" y="1850287"/>
              <a:ext cx="1010805" cy="270063"/>
              <a:chOff x="2463282" y="4073187"/>
              <a:chExt cx="1010805" cy="230832"/>
            </a:xfrm>
          </p:grpSpPr>
          <p:pic>
            <p:nvPicPr>
              <p:cNvPr id="427" name="Picture 426">
                <a:extLst>
                  <a:ext uri="{FF2B5EF4-FFF2-40B4-BE49-F238E27FC236}">
                    <a16:creationId xmlns:a16="http://schemas.microsoft.com/office/drawing/2014/main" id="{4DCF7756-3A93-7629-7A47-5027ACCFC3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826387" y="4085728"/>
                <a:ext cx="647700" cy="190500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sp>
            <p:nvSpPr>
              <p:cNvPr id="428" name="TextBox 427">
                <a:extLst>
                  <a:ext uri="{FF2B5EF4-FFF2-40B4-BE49-F238E27FC236}">
                    <a16:creationId xmlns:a16="http://schemas.microsoft.com/office/drawing/2014/main" id="{64EB8150-F348-0030-3049-0D0BA8E9E147}"/>
                  </a:ext>
                </a:extLst>
              </p:cNvPr>
              <p:cNvSpPr txBox="1"/>
              <p:nvPr/>
            </p:nvSpPr>
            <p:spPr>
              <a:xfrm>
                <a:off x="2463282" y="4073187"/>
                <a:ext cx="4283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</p:grpSp>
        <p:sp>
          <p:nvSpPr>
            <p:cNvPr id="429" name="TextBox 428">
              <a:extLst>
                <a:ext uri="{FF2B5EF4-FFF2-40B4-BE49-F238E27FC236}">
                  <a16:creationId xmlns:a16="http://schemas.microsoft.com/office/drawing/2014/main" id="{868C7490-1A14-4A3E-73DB-1D9CA51A9AAD}"/>
                </a:ext>
              </a:extLst>
            </p:cNvPr>
            <p:cNvSpPr txBox="1"/>
            <p:nvPr/>
          </p:nvSpPr>
          <p:spPr>
            <a:xfrm>
              <a:off x="1035767" y="1354926"/>
              <a:ext cx="52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-HNE:</a:t>
              </a:r>
            </a:p>
          </p:txBody>
        </p:sp>
        <p:grpSp>
          <p:nvGrpSpPr>
            <p:cNvPr id="430" name="Group 429">
              <a:extLst>
                <a:ext uri="{FF2B5EF4-FFF2-40B4-BE49-F238E27FC236}">
                  <a16:creationId xmlns:a16="http://schemas.microsoft.com/office/drawing/2014/main" id="{A667989D-6C42-9445-A3A9-2266C62304EC}"/>
                </a:ext>
              </a:extLst>
            </p:cNvPr>
            <p:cNvGrpSpPr/>
            <p:nvPr/>
          </p:nvGrpSpPr>
          <p:grpSpPr>
            <a:xfrm>
              <a:off x="1532237" y="1327289"/>
              <a:ext cx="512151" cy="271804"/>
              <a:chOff x="1179092" y="3561292"/>
              <a:chExt cx="512151" cy="232321"/>
            </a:xfrm>
          </p:grpSpPr>
          <p:sp>
            <p:nvSpPr>
              <p:cNvPr id="431" name="TextBox 430">
                <a:extLst>
                  <a:ext uri="{FF2B5EF4-FFF2-40B4-BE49-F238E27FC236}">
                    <a16:creationId xmlns:a16="http://schemas.microsoft.com/office/drawing/2014/main" id="{CD5683D0-D49B-4C82-76EA-8D72CEF93EA4}"/>
                  </a:ext>
                </a:extLst>
              </p:cNvPr>
              <p:cNvSpPr txBox="1"/>
              <p:nvPr/>
            </p:nvSpPr>
            <p:spPr>
              <a:xfrm>
                <a:off x="1179092" y="3561292"/>
                <a:ext cx="231154" cy="2236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32" name="TextBox 431">
                <a:extLst>
                  <a:ext uri="{FF2B5EF4-FFF2-40B4-BE49-F238E27FC236}">
                    <a16:creationId xmlns:a16="http://schemas.microsoft.com/office/drawing/2014/main" id="{45DF21B4-6115-1251-3C13-6416C5458451}"/>
                  </a:ext>
                </a:extLst>
              </p:cNvPr>
              <p:cNvSpPr txBox="1"/>
              <p:nvPr/>
            </p:nvSpPr>
            <p:spPr>
              <a:xfrm>
                <a:off x="1424823" y="3570005"/>
                <a:ext cx="266420" cy="2236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</p:grpSp>
        <p:sp>
          <p:nvSpPr>
            <p:cNvPr id="433" name="TextBox 432">
              <a:extLst>
                <a:ext uri="{FF2B5EF4-FFF2-40B4-BE49-F238E27FC236}">
                  <a16:creationId xmlns:a16="http://schemas.microsoft.com/office/drawing/2014/main" id="{0F8FAC85-3F57-4C21-DF1F-35067741474C}"/>
                </a:ext>
              </a:extLst>
            </p:cNvPr>
            <p:cNvSpPr txBox="1"/>
            <p:nvPr/>
          </p:nvSpPr>
          <p:spPr>
            <a:xfrm>
              <a:off x="2024454" y="1572912"/>
              <a:ext cx="362600" cy="25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 15</a:t>
              </a:r>
            </a:p>
          </p:txBody>
        </p:sp>
        <p:sp>
          <p:nvSpPr>
            <p:cNvPr id="434" name="TextBox 433">
              <a:extLst>
                <a:ext uri="{FF2B5EF4-FFF2-40B4-BE49-F238E27FC236}">
                  <a16:creationId xmlns:a16="http://schemas.microsoft.com/office/drawing/2014/main" id="{66418F42-CC59-3196-56CB-BF39A0062820}"/>
                </a:ext>
              </a:extLst>
            </p:cNvPr>
            <p:cNvSpPr txBox="1"/>
            <p:nvPr/>
          </p:nvSpPr>
          <p:spPr>
            <a:xfrm>
              <a:off x="2054958" y="1402679"/>
              <a:ext cx="367408" cy="25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5" name="TextBox 434">
              <a:extLst>
                <a:ext uri="{FF2B5EF4-FFF2-40B4-BE49-F238E27FC236}">
                  <a16:creationId xmlns:a16="http://schemas.microsoft.com/office/drawing/2014/main" id="{F50D69A6-8364-C961-5F34-E8D271E1E2FE}"/>
                </a:ext>
              </a:extLst>
            </p:cNvPr>
            <p:cNvSpPr txBox="1"/>
            <p:nvPr/>
          </p:nvSpPr>
          <p:spPr>
            <a:xfrm>
              <a:off x="2032593" y="1839167"/>
              <a:ext cx="362600" cy="25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 35</a:t>
              </a:r>
            </a:p>
          </p:txBody>
        </p:sp>
        <p:pic>
          <p:nvPicPr>
            <p:cNvPr id="436" name="Picture 435">
              <a:extLst>
                <a:ext uri="{FF2B5EF4-FFF2-40B4-BE49-F238E27FC236}">
                  <a16:creationId xmlns:a16="http://schemas.microsoft.com/office/drawing/2014/main" id="{7647640E-97DD-38C8-FB0A-19EFABCADC0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940199" y="1569520"/>
              <a:ext cx="642367" cy="236332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437" name="TextBox 436">
              <a:extLst>
                <a:ext uri="{FF2B5EF4-FFF2-40B4-BE49-F238E27FC236}">
                  <a16:creationId xmlns:a16="http://schemas.microsoft.com/office/drawing/2014/main" id="{9CC01F7E-7958-8C6D-CF2D-86E19DF4E47A}"/>
                </a:ext>
              </a:extLst>
            </p:cNvPr>
            <p:cNvSpPr txBox="1"/>
            <p:nvPr/>
          </p:nvSpPr>
          <p:spPr>
            <a:xfrm>
              <a:off x="2403202" y="1575318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IM17B</a:t>
              </a:r>
            </a:p>
          </p:txBody>
        </p:sp>
        <p:grpSp>
          <p:nvGrpSpPr>
            <p:cNvPr id="438" name="Group 437">
              <a:extLst>
                <a:ext uri="{FF2B5EF4-FFF2-40B4-BE49-F238E27FC236}">
                  <a16:creationId xmlns:a16="http://schemas.microsoft.com/office/drawing/2014/main" id="{A5750F03-2E50-B007-B29B-B9A34FCB94DF}"/>
                </a:ext>
              </a:extLst>
            </p:cNvPr>
            <p:cNvGrpSpPr/>
            <p:nvPr/>
          </p:nvGrpSpPr>
          <p:grpSpPr>
            <a:xfrm>
              <a:off x="2566907" y="1843714"/>
              <a:ext cx="1017761" cy="230832"/>
              <a:chOff x="3894681" y="4036313"/>
              <a:chExt cx="1017761" cy="230832"/>
            </a:xfrm>
          </p:grpSpPr>
          <p:pic>
            <p:nvPicPr>
              <p:cNvPr id="439" name="Picture 438">
                <a:extLst>
                  <a:ext uri="{FF2B5EF4-FFF2-40B4-BE49-F238E27FC236}">
                    <a16:creationId xmlns:a16="http://schemas.microsoft.com/office/drawing/2014/main" id="{C48A0D5E-C281-717F-15F0-E2D95046E1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265923" y="4058555"/>
                <a:ext cx="646519" cy="203200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sp>
            <p:nvSpPr>
              <p:cNvPr id="440" name="TextBox 439">
                <a:extLst>
                  <a:ext uri="{FF2B5EF4-FFF2-40B4-BE49-F238E27FC236}">
                    <a16:creationId xmlns:a16="http://schemas.microsoft.com/office/drawing/2014/main" id="{C4A93842-F55A-C0CD-0FED-D506A389AC0E}"/>
                  </a:ext>
                </a:extLst>
              </p:cNvPr>
              <p:cNvSpPr txBox="1"/>
              <p:nvPr/>
            </p:nvSpPr>
            <p:spPr>
              <a:xfrm>
                <a:off x="3894681" y="4036313"/>
                <a:ext cx="4283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</p:grpSp>
        <p:sp>
          <p:nvSpPr>
            <p:cNvPr id="441" name="TextBox 440">
              <a:extLst>
                <a:ext uri="{FF2B5EF4-FFF2-40B4-BE49-F238E27FC236}">
                  <a16:creationId xmlns:a16="http://schemas.microsoft.com/office/drawing/2014/main" id="{46AFDE55-382F-A97A-D044-F12986AF8E5A}"/>
                </a:ext>
              </a:extLst>
            </p:cNvPr>
            <p:cNvSpPr txBox="1"/>
            <p:nvPr/>
          </p:nvSpPr>
          <p:spPr>
            <a:xfrm>
              <a:off x="3503855" y="1594729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 15</a:t>
              </a:r>
            </a:p>
          </p:txBody>
        </p:sp>
        <p:sp>
          <p:nvSpPr>
            <p:cNvPr id="442" name="TextBox 441">
              <a:extLst>
                <a:ext uri="{FF2B5EF4-FFF2-40B4-BE49-F238E27FC236}">
                  <a16:creationId xmlns:a16="http://schemas.microsoft.com/office/drawing/2014/main" id="{E565D48D-A8C6-3F5E-9C1C-ADDC187031B5}"/>
                </a:ext>
              </a:extLst>
            </p:cNvPr>
            <p:cNvSpPr txBox="1"/>
            <p:nvPr/>
          </p:nvSpPr>
          <p:spPr>
            <a:xfrm>
              <a:off x="3530423" y="1415301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3" name="TextBox 442">
              <a:extLst>
                <a:ext uri="{FF2B5EF4-FFF2-40B4-BE49-F238E27FC236}">
                  <a16:creationId xmlns:a16="http://schemas.microsoft.com/office/drawing/2014/main" id="{C84E00B4-3228-F30B-C2ED-D3438EBEED85}"/>
                </a:ext>
              </a:extLst>
            </p:cNvPr>
            <p:cNvSpPr txBox="1"/>
            <p:nvPr/>
          </p:nvSpPr>
          <p:spPr>
            <a:xfrm>
              <a:off x="3504213" y="1824474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 35</a:t>
              </a:r>
            </a:p>
          </p:txBody>
        </p:sp>
        <p:sp>
          <p:nvSpPr>
            <p:cNvPr id="444" name="TextBox 443">
              <a:extLst>
                <a:ext uri="{FF2B5EF4-FFF2-40B4-BE49-F238E27FC236}">
                  <a16:creationId xmlns:a16="http://schemas.microsoft.com/office/drawing/2014/main" id="{7EE1C78D-8028-4F11-9B3D-EC57A4D85952}"/>
                </a:ext>
              </a:extLst>
            </p:cNvPr>
            <p:cNvSpPr txBox="1"/>
            <p:nvPr/>
          </p:nvSpPr>
          <p:spPr>
            <a:xfrm>
              <a:off x="1451429" y="2075493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.6</a:t>
              </a:r>
            </a:p>
          </p:txBody>
        </p:sp>
        <p:sp>
          <p:nvSpPr>
            <p:cNvPr id="445" name="TextBox 444">
              <a:extLst>
                <a:ext uri="{FF2B5EF4-FFF2-40B4-BE49-F238E27FC236}">
                  <a16:creationId xmlns:a16="http://schemas.microsoft.com/office/drawing/2014/main" id="{294D4121-D297-48AA-60FB-4B8B87A5B57A}"/>
                </a:ext>
              </a:extLst>
            </p:cNvPr>
            <p:cNvSpPr txBox="1"/>
            <p:nvPr/>
          </p:nvSpPr>
          <p:spPr>
            <a:xfrm>
              <a:off x="1768772" y="2075493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.6</a:t>
              </a:r>
            </a:p>
          </p:txBody>
        </p:sp>
        <p:sp>
          <p:nvSpPr>
            <p:cNvPr id="446" name="TextBox 445">
              <a:extLst>
                <a:ext uri="{FF2B5EF4-FFF2-40B4-BE49-F238E27FC236}">
                  <a16:creationId xmlns:a16="http://schemas.microsoft.com/office/drawing/2014/main" id="{13168240-7FF8-4C1C-8230-4E33A3B4DE16}"/>
                </a:ext>
              </a:extLst>
            </p:cNvPr>
            <p:cNvSpPr txBox="1"/>
            <p:nvPr/>
          </p:nvSpPr>
          <p:spPr>
            <a:xfrm>
              <a:off x="2952007" y="2052148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.3</a:t>
              </a:r>
            </a:p>
          </p:txBody>
        </p:sp>
        <p:sp>
          <p:nvSpPr>
            <p:cNvPr id="447" name="TextBox 446">
              <a:extLst>
                <a:ext uri="{FF2B5EF4-FFF2-40B4-BE49-F238E27FC236}">
                  <a16:creationId xmlns:a16="http://schemas.microsoft.com/office/drawing/2014/main" id="{67CA773C-82B0-9178-A2E5-B61B73715FE6}"/>
                </a:ext>
              </a:extLst>
            </p:cNvPr>
            <p:cNvSpPr txBox="1"/>
            <p:nvPr/>
          </p:nvSpPr>
          <p:spPr>
            <a:xfrm>
              <a:off x="3228474" y="2051662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.8</a:t>
              </a:r>
            </a:p>
          </p:txBody>
        </p:sp>
        <p:sp>
          <p:nvSpPr>
            <p:cNvPr id="448" name="TextBox 447">
              <a:extLst>
                <a:ext uri="{FF2B5EF4-FFF2-40B4-BE49-F238E27FC236}">
                  <a16:creationId xmlns:a16="http://schemas.microsoft.com/office/drawing/2014/main" id="{7211D091-D16D-1177-E250-C9F5B5DA9405}"/>
                </a:ext>
              </a:extLst>
            </p:cNvPr>
            <p:cNvSpPr txBox="1"/>
            <p:nvPr/>
          </p:nvSpPr>
          <p:spPr>
            <a:xfrm>
              <a:off x="3915721" y="1637068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AR</a:t>
              </a:r>
            </a:p>
          </p:txBody>
        </p:sp>
        <p:pic>
          <p:nvPicPr>
            <p:cNvPr id="449" name="Picture 448">
              <a:extLst>
                <a:ext uri="{FF2B5EF4-FFF2-40B4-BE49-F238E27FC236}">
                  <a16:creationId xmlns:a16="http://schemas.microsoft.com/office/drawing/2014/main" id="{2EF1281E-A7C2-150A-10B4-12652701B7B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363904" y="1319998"/>
              <a:ext cx="635000" cy="1016000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450" name="Picture 449">
              <a:extLst>
                <a:ext uri="{FF2B5EF4-FFF2-40B4-BE49-F238E27FC236}">
                  <a16:creationId xmlns:a16="http://schemas.microsoft.com/office/drawing/2014/main" id="{F4EBA1E9-602C-EC93-E48B-4F35D4DF941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372702" y="2387155"/>
              <a:ext cx="635000" cy="168469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451" name="TextBox 450">
              <a:extLst>
                <a:ext uri="{FF2B5EF4-FFF2-40B4-BE49-F238E27FC236}">
                  <a16:creationId xmlns:a16="http://schemas.microsoft.com/office/drawing/2014/main" id="{CCC035A4-5516-B32B-238D-1A940A3CC54B}"/>
                </a:ext>
              </a:extLst>
            </p:cNvPr>
            <p:cNvSpPr txBox="1"/>
            <p:nvPr/>
          </p:nvSpPr>
          <p:spPr>
            <a:xfrm>
              <a:off x="3999237" y="2360082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452" name="TextBox 451">
              <a:extLst>
                <a:ext uri="{FF2B5EF4-FFF2-40B4-BE49-F238E27FC236}">
                  <a16:creationId xmlns:a16="http://schemas.microsoft.com/office/drawing/2014/main" id="{FDF8C15B-059A-242B-1A5E-16166E262FB8}"/>
                </a:ext>
              </a:extLst>
            </p:cNvPr>
            <p:cNvSpPr txBox="1"/>
            <p:nvPr/>
          </p:nvSpPr>
          <p:spPr>
            <a:xfrm>
              <a:off x="4919381" y="1788402"/>
              <a:ext cx="4203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 100</a:t>
              </a:r>
            </a:p>
          </p:txBody>
        </p:sp>
        <p:sp>
          <p:nvSpPr>
            <p:cNvPr id="453" name="TextBox 452">
              <a:extLst>
                <a:ext uri="{FF2B5EF4-FFF2-40B4-BE49-F238E27FC236}">
                  <a16:creationId xmlns:a16="http://schemas.microsoft.com/office/drawing/2014/main" id="{155DDBA5-7EB3-ED40-82DF-4648C9B068C6}"/>
                </a:ext>
              </a:extLst>
            </p:cNvPr>
            <p:cNvSpPr txBox="1"/>
            <p:nvPr/>
          </p:nvSpPr>
          <p:spPr>
            <a:xfrm>
              <a:off x="4916854" y="1648444"/>
              <a:ext cx="4203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 130</a:t>
              </a:r>
            </a:p>
          </p:txBody>
        </p:sp>
        <p:sp>
          <p:nvSpPr>
            <p:cNvPr id="454" name="TextBox 453">
              <a:extLst>
                <a:ext uri="{FF2B5EF4-FFF2-40B4-BE49-F238E27FC236}">
                  <a16:creationId xmlns:a16="http://schemas.microsoft.com/office/drawing/2014/main" id="{DD661F94-C74E-A1A1-74C5-5E4387BA93E9}"/>
                </a:ext>
              </a:extLst>
            </p:cNvPr>
            <p:cNvSpPr txBox="1"/>
            <p:nvPr/>
          </p:nvSpPr>
          <p:spPr>
            <a:xfrm>
              <a:off x="4925153" y="1928360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 70</a:t>
              </a:r>
            </a:p>
          </p:txBody>
        </p:sp>
        <p:sp>
          <p:nvSpPr>
            <p:cNvPr id="455" name="TextBox 454">
              <a:extLst>
                <a:ext uri="{FF2B5EF4-FFF2-40B4-BE49-F238E27FC236}">
                  <a16:creationId xmlns:a16="http://schemas.microsoft.com/office/drawing/2014/main" id="{D4ABF138-B049-1AD7-CEB2-DAF71C54AD8D}"/>
                </a:ext>
              </a:extLst>
            </p:cNvPr>
            <p:cNvSpPr txBox="1"/>
            <p:nvPr/>
          </p:nvSpPr>
          <p:spPr>
            <a:xfrm>
              <a:off x="4952426" y="1244026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6" name="TextBox 455">
              <a:extLst>
                <a:ext uri="{FF2B5EF4-FFF2-40B4-BE49-F238E27FC236}">
                  <a16:creationId xmlns:a16="http://schemas.microsoft.com/office/drawing/2014/main" id="{FA165626-A1E1-BB3D-F550-45CAEDA81556}"/>
                </a:ext>
              </a:extLst>
            </p:cNvPr>
            <p:cNvSpPr txBox="1"/>
            <p:nvPr/>
          </p:nvSpPr>
          <p:spPr>
            <a:xfrm>
              <a:off x="4925652" y="2351806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 35</a:t>
              </a:r>
            </a:p>
          </p:txBody>
        </p:sp>
        <p:sp>
          <p:nvSpPr>
            <p:cNvPr id="457" name="TextBox 456">
              <a:extLst>
                <a:ext uri="{FF2B5EF4-FFF2-40B4-BE49-F238E27FC236}">
                  <a16:creationId xmlns:a16="http://schemas.microsoft.com/office/drawing/2014/main" id="{877A5599-553D-F065-88DD-167F8340D1B6}"/>
                </a:ext>
              </a:extLst>
            </p:cNvPr>
            <p:cNvSpPr txBox="1"/>
            <p:nvPr/>
          </p:nvSpPr>
          <p:spPr>
            <a:xfrm>
              <a:off x="4377323" y="252733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.6</a:t>
              </a:r>
            </a:p>
          </p:txBody>
        </p:sp>
        <p:sp>
          <p:nvSpPr>
            <p:cNvPr id="458" name="TextBox 457">
              <a:extLst>
                <a:ext uri="{FF2B5EF4-FFF2-40B4-BE49-F238E27FC236}">
                  <a16:creationId xmlns:a16="http://schemas.microsoft.com/office/drawing/2014/main" id="{46098CA3-643A-32A8-3CAF-BD12E6576B37}"/>
                </a:ext>
              </a:extLst>
            </p:cNvPr>
            <p:cNvSpPr txBox="1"/>
            <p:nvPr/>
          </p:nvSpPr>
          <p:spPr>
            <a:xfrm>
              <a:off x="4673051" y="253110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.2</a:t>
              </a:r>
            </a:p>
          </p:txBody>
        </p:sp>
        <p:sp>
          <p:nvSpPr>
            <p:cNvPr id="459" name="TextBox 458">
              <a:extLst>
                <a:ext uri="{FF2B5EF4-FFF2-40B4-BE49-F238E27FC236}">
                  <a16:creationId xmlns:a16="http://schemas.microsoft.com/office/drawing/2014/main" id="{EDB94E23-2611-A19C-9ACD-DA40FDA71220}"/>
                </a:ext>
              </a:extLst>
            </p:cNvPr>
            <p:cNvSpPr txBox="1"/>
            <p:nvPr/>
          </p:nvSpPr>
          <p:spPr>
            <a:xfrm>
              <a:off x="1508090" y="1160228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792</a:t>
              </a:r>
            </a:p>
          </p:txBody>
        </p:sp>
        <p:sp>
          <p:nvSpPr>
            <p:cNvPr id="460" name="TextBox 459">
              <a:extLst>
                <a:ext uri="{FF2B5EF4-FFF2-40B4-BE49-F238E27FC236}">
                  <a16:creationId xmlns:a16="http://schemas.microsoft.com/office/drawing/2014/main" id="{3405CCF6-EC40-B57E-907D-9F4165B0C94B}"/>
                </a:ext>
              </a:extLst>
            </p:cNvPr>
            <p:cNvSpPr txBox="1"/>
            <p:nvPr/>
          </p:nvSpPr>
          <p:spPr>
            <a:xfrm>
              <a:off x="2521001" y="1378875"/>
              <a:ext cx="52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-HNE:</a:t>
              </a:r>
            </a:p>
          </p:txBody>
        </p:sp>
        <p:grpSp>
          <p:nvGrpSpPr>
            <p:cNvPr id="461" name="Group 460">
              <a:extLst>
                <a:ext uri="{FF2B5EF4-FFF2-40B4-BE49-F238E27FC236}">
                  <a16:creationId xmlns:a16="http://schemas.microsoft.com/office/drawing/2014/main" id="{1DECA8EA-30DF-BD8A-01EE-BF17B72ADA28}"/>
                </a:ext>
              </a:extLst>
            </p:cNvPr>
            <p:cNvGrpSpPr/>
            <p:nvPr/>
          </p:nvGrpSpPr>
          <p:grpSpPr>
            <a:xfrm>
              <a:off x="3017471" y="1351238"/>
              <a:ext cx="512151" cy="271804"/>
              <a:chOff x="1179092" y="3561292"/>
              <a:chExt cx="512151" cy="232321"/>
            </a:xfrm>
          </p:grpSpPr>
          <p:sp>
            <p:nvSpPr>
              <p:cNvPr id="462" name="TextBox 461">
                <a:extLst>
                  <a:ext uri="{FF2B5EF4-FFF2-40B4-BE49-F238E27FC236}">
                    <a16:creationId xmlns:a16="http://schemas.microsoft.com/office/drawing/2014/main" id="{8029F713-7AE6-6163-CF9D-AEE74B7CA557}"/>
                  </a:ext>
                </a:extLst>
              </p:cNvPr>
              <p:cNvSpPr txBox="1"/>
              <p:nvPr/>
            </p:nvSpPr>
            <p:spPr>
              <a:xfrm>
                <a:off x="1179092" y="3561292"/>
                <a:ext cx="231154" cy="2236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63" name="TextBox 462">
                <a:extLst>
                  <a:ext uri="{FF2B5EF4-FFF2-40B4-BE49-F238E27FC236}">
                    <a16:creationId xmlns:a16="http://schemas.microsoft.com/office/drawing/2014/main" id="{8D4FD0E4-DB78-5192-3100-73E186D69B62}"/>
                  </a:ext>
                </a:extLst>
              </p:cNvPr>
              <p:cNvSpPr txBox="1"/>
              <p:nvPr/>
            </p:nvSpPr>
            <p:spPr>
              <a:xfrm>
                <a:off x="1424823" y="3570005"/>
                <a:ext cx="266420" cy="2236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</p:grpSp>
        <p:sp>
          <p:nvSpPr>
            <p:cNvPr id="464" name="TextBox 463">
              <a:extLst>
                <a:ext uri="{FF2B5EF4-FFF2-40B4-BE49-F238E27FC236}">
                  <a16:creationId xmlns:a16="http://schemas.microsoft.com/office/drawing/2014/main" id="{DA953128-17D7-E148-B848-4AEBBD676F36}"/>
                </a:ext>
              </a:extLst>
            </p:cNvPr>
            <p:cNvSpPr txBox="1"/>
            <p:nvPr/>
          </p:nvSpPr>
          <p:spPr>
            <a:xfrm>
              <a:off x="2979900" y="1171511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792</a:t>
              </a:r>
            </a:p>
          </p:txBody>
        </p:sp>
        <p:sp>
          <p:nvSpPr>
            <p:cNvPr id="465" name="TextBox 464">
              <a:extLst>
                <a:ext uri="{FF2B5EF4-FFF2-40B4-BE49-F238E27FC236}">
                  <a16:creationId xmlns:a16="http://schemas.microsoft.com/office/drawing/2014/main" id="{9E7B9700-2423-E0C0-0F6D-C28A89E74B73}"/>
                </a:ext>
              </a:extLst>
            </p:cNvPr>
            <p:cNvSpPr txBox="1"/>
            <p:nvPr/>
          </p:nvSpPr>
          <p:spPr>
            <a:xfrm>
              <a:off x="3942638" y="1119515"/>
              <a:ext cx="52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-HNE:</a:t>
              </a:r>
            </a:p>
          </p:txBody>
        </p:sp>
        <p:grpSp>
          <p:nvGrpSpPr>
            <p:cNvPr id="466" name="Group 465">
              <a:extLst>
                <a:ext uri="{FF2B5EF4-FFF2-40B4-BE49-F238E27FC236}">
                  <a16:creationId xmlns:a16="http://schemas.microsoft.com/office/drawing/2014/main" id="{825B6286-D823-D958-8879-F65D4ADA6712}"/>
                </a:ext>
              </a:extLst>
            </p:cNvPr>
            <p:cNvGrpSpPr/>
            <p:nvPr/>
          </p:nvGrpSpPr>
          <p:grpSpPr>
            <a:xfrm>
              <a:off x="4439108" y="1091878"/>
              <a:ext cx="512151" cy="271804"/>
              <a:chOff x="1179092" y="3561292"/>
              <a:chExt cx="512151" cy="232321"/>
            </a:xfrm>
          </p:grpSpPr>
          <p:sp>
            <p:nvSpPr>
              <p:cNvPr id="467" name="TextBox 466">
                <a:extLst>
                  <a:ext uri="{FF2B5EF4-FFF2-40B4-BE49-F238E27FC236}">
                    <a16:creationId xmlns:a16="http://schemas.microsoft.com/office/drawing/2014/main" id="{901907FF-EFBF-D49B-07D0-08F80F941C09}"/>
                  </a:ext>
                </a:extLst>
              </p:cNvPr>
              <p:cNvSpPr txBox="1"/>
              <p:nvPr/>
            </p:nvSpPr>
            <p:spPr>
              <a:xfrm>
                <a:off x="1179092" y="3561292"/>
                <a:ext cx="231154" cy="2236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68" name="TextBox 467">
                <a:extLst>
                  <a:ext uri="{FF2B5EF4-FFF2-40B4-BE49-F238E27FC236}">
                    <a16:creationId xmlns:a16="http://schemas.microsoft.com/office/drawing/2014/main" id="{15056F55-3E4D-4793-7D92-679E79BA1FDE}"/>
                  </a:ext>
                </a:extLst>
              </p:cNvPr>
              <p:cNvSpPr txBox="1"/>
              <p:nvPr/>
            </p:nvSpPr>
            <p:spPr>
              <a:xfrm>
                <a:off x="1424823" y="3570005"/>
                <a:ext cx="266420" cy="2236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</p:grpSp>
        <p:sp>
          <p:nvSpPr>
            <p:cNvPr id="469" name="TextBox 468">
              <a:extLst>
                <a:ext uri="{FF2B5EF4-FFF2-40B4-BE49-F238E27FC236}">
                  <a16:creationId xmlns:a16="http://schemas.microsoft.com/office/drawing/2014/main" id="{66749FAA-99FD-7936-5E93-CC1DCA77897F}"/>
                </a:ext>
              </a:extLst>
            </p:cNvPr>
            <p:cNvSpPr txBox="1"/>
            <p:nvPr/>
          </p:nvSpPr>
          <p:spPr>
            <a:xfrm>
              <a:off x="4403424" y="968182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792</a:t>
              </a:r>
            </a:p>
          </p:txBody>
        </p:sp>
        <p:sp>
          <p:nvSpPr>
            <p:cNvPr id="470" name="Left Bracket 469">
              <a:extLst>
                <a:ext uri="{FF2B5EF4-FFF2-40B4-BE49-F238E27FC236}">
                  <a16:creationId xmlns:a16="http://schemas.microsoft.com/office/drawing/2014/main" id="{4A0390EF-E3FC-3FE0-2BEC-A162158BE1FA}"/>
                </a:ext>
              </a:extLst>
            </p:cNvPr>
            <p:cNvSpPr/>
            <p:nvPr/>
          </p:nvSpPr>
          <p:spPr>
            <a:xfrm>
              <a:off x="4275620" y="1378056"/>
              <a:ext cx="45719" cy="797951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1" name="TextBox 470">
              <a:extLst>
                <a:ext uri="{FF2B5EF4-FFF2-40B4-BE49-F238E27FC236}">
                  <a16:creationId xmlns:a16="http://schemas.microsoft.com/office/drawing/2014/main" id="{4D0B103A-2A6E-E48E-CA91-5908D1B951EE}"/>
                </a:ext>
              </a:extLst>
            </p:cNvPr>
            <p:cNvSpPr txBox="1"/>
            <p:nvPr/>
          </p:nvSpPr>
          <p:spPr>
            <a:xfrm>
              <a:off x="943303" y="888909"/>
              <a:ext cx="3042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AC881057-90B3-8F03-7DF8-21559E5A899A}"/>
              </a:ext>
            </a:extLst>
          </p:cNvPr>
          <p:cNvSpPr txBox="1"/>
          <p:nvPr/>
        </p:nvSpPr>
        <p:spPr>
          <a:xfrm>
            <a:off x="595079" y="3747289"/>
            <a:ext cx="5485279" cy="19970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tabLst>
                <a:tab pos="2369820" algn="l"/>
              </a:tabLst>
            </a:pP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igure S12: Effect of lipid peroxidation on the abundance of TIM17A in lung carcinoma cells.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(A) Lysates from H1792 cells treated for 3 hours with 80 μM of 4-hydroxynonenal (4-HNE) were immunoblotted with TIM17A and Tim17B antibodies. Numbers correspond to band intensity normalized to actin control. (B) Lysates from H1792 cells treated for 3 hours with 80 μM of 4-hydroxynonenal (4-HNE) were immunoblotted with PAR antibodies. Numbers correspond to band intensity normalized to actin control.</a:t>
            </a:r>
          </a:p>
        </p:txBody>
      </p:sp>
    </p:spTree>
    <p:extLst>
      <p:ext uri="{BB962C8B-B14F-4D97-AF65-F5344CB8AC3E}">
        <p14:creationId xmlns:p14="http://schemas.microsoft.com/office/powerpoint/2010/main" val="2594360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07</TotalTime>
  <Words>140</Words>
  <Application>Microsoft Macintosh PowerPoint</Application>
  <PresentationFormat>Custom</PresentationFormat>
  <Paragraphs>4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z, Begona</dc:creator>
  <cp:lastModifiedBy>Diaz, Begona</cp:lastModifiedBy>
  <cp:revision>142</cp:revision>
  <dcterms:created xsi:type="dcterms:W3CDTF">2023-03-19T23:47:27Z</dcterms:created>
  <dcterms:modified xsi:type="dcterms:W3CDTF">2024-06-18T18:23:27Z</dcterms:modified>
</cp:coreProperties>
</file>